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66" d="100"/>
          <a:sy n="66" d="100"/>
        </p:scale>
        <p:origin x="3318" y="9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4608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7367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258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664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2468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17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056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17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919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8061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242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B81A3-08BB-4935-B2FF-E9D52AFDEFF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BB5E6-56E1-4E21-9027-70FB12D99D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2926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18979" y="1712507"/>
            <a:ext cx="22518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Search criteria for PubMed: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18979" y="233534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1344" y="2335349"/>
            <a:ext cx="5733575" cy="1427611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418979" y="3882647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Search criteria for OVID EMBASE: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11344" y="4377509"/>
            <a:ext cx="2483372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) glyburide.mp.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)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buride.ti,a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glyburide/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) 2 or 3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) (gestation* adj3diabet*).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,a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)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pregnancy diabetes mellitus/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) (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gnan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adj3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bet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).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,a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) 5 or 6 or 7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) 4 and 8</a:t>
            </a:r>
            <a:endParaRPr lang="en-GB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511344" y="6178001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C) Search criteria for MEDLINE: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511344" y="6534364"/>
            <a:ext cx="3429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 glyburide.mp.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)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buride.ti,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glyburide/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) 2 or 3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) (gestation* adj3diabet*).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,ab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)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gna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adj3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abe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).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,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) 5 or 6</a:t>
            </a:r>
          </a:p>
          <a:p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) 4 and 7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11344" y="8183388"/>
            <a:ext cx="2731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) Search criteria for Web of Science: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511344" y="8731541"/>
            <a:ext cx="5526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ibenclamid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lyburide AND diabetes mellitus AND diabetes i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gnancy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11344" y="9187361"/>
            <a:ext cx="3244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)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arch criteria for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chrane Database:</a:t>
            </a:r>
            <a:r>
              <a:rPr lang="en-GB" sz="1200" dirty="0" smtClean="0"/>
              <a:t> 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511344" y="9643181"/>
            <a:ext cx="5244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ibenclamid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glyburide AND diabetes mellitus AND diabetes in pregnancy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11344" y="10242065"/>
            <a:ext cx="2782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) Search criteria for clinical trials.gov 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11344" y="10823416"/>
            <a:ext cx="54480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ibenclamid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lyburide AND diabetes mellitus AND diabetes in pregnancy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buride | Interventional Studies | Gestational Diabetes | glyburide |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ibenclamide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18979" y="1118187"/>
            <a:ext cx="2136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Text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bas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arch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iteria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4733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</TotalTime>
  <Words>198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Jane Adkins</cp:lastModifiedBy>
  <cp:revision>7</cp:revision>
  <cp:lastPrinted>2019-07-02T07:21:21Z</cp:lastPrinted>
  <dcterms:created xsi:type="dcterms:W3CDTF">2019-07-01T12:08:55Z</dcterms:created>
  <dcterms:modified xsi:type="dcterms:W3CDTF">2020-02-20T08:08:11Z</dcterms:modified>
</cp:coreProperties>
</file>